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EAA83A-2EE2-41A6-ABF6-A191DAD50E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B75FA-47BE-4832-AB4E-A7B74643C2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833069-9106-4230-AB4F-ABE153F159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E29A6B-7264-4976-B671-1AC51BFF53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8D776B-4ADE-4329-AABE-249F704819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AC94C3-F1FF-4557-92AB-AE268D49B7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CBBA97-70ED-4659-BBE3-AE0425E5E2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0158D2-1CFB-4954-A202-809894249A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C7147A-46E7-4630-A377-AC8A431A0C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A9AD02-1D10-4A92-AE5E-3C214090D1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DA7D1-37C9-4304-8E0E-CB4A0A053A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341FEC-8F9D-4795-BDAE-3745F3D969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5DB5EA-055D-4990-8F8A-B4382A0D2CE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481040" y="938160"/>
          <a:ext cx="5605560" cy="4395960"/>
        </p:xfrm>
        <a:graphic>
          <a:graphicData uri="http://schemas.openxmlformats.org/drawingml/2006/table">
            <a:tbl>
              <a:tblPr/>
              <a:tblGrid>
                <a:gridCol w="679680"/>
                <a:gridCol w="1065240"/>
                <a:gridCol w="998280"/>
                <a:gridCol w="1596960"/>
                <a:gridCol w="1265400"/>
              </a:tblGrid>
              <a:tr h="2206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4"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imary Tumor (Mammary fat pad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080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ampl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E-cadher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Β-caten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ibronect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ERα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772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yto/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yto/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66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yto/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yto/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772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yto/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yto/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66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yto/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yto/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772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yto/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yto/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06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4"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Lung Metastasi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080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ampl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E-cadher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Β-caten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ibronect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ERα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80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 (variable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62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 (variable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 (variable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80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 (variable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62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 (variable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 (variable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772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 (variable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06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4"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Liver Metastasi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080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ampl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E-cadher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Β-caten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ibronect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ERα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80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 (larger lesion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62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 (larger lesion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80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 (larger lesion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62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 (larger lesion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808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mbra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itive (larger lesion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gati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16T20:55:43Z</dcterms:created>
  <dc:creator>Carolyn</dc:creator>
  <dc:description/>
  <dc:language>en-US</dc:language>
  <cp:lastModifiedBy>Carolyn</cp:lastModifiedBy>
  <dcterms:modified xsi:type="dcterms:W3CDTF">2011-11-23T19:37:28Z</dcterms:modified>
  <cp:revision>4</cp:revision>
  <dc:subject/>
  <dc:title>Slide 1</dc:title>
</cp:coreProperties>
</file>